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6EE3529-1FF9-4189-B9E8-E59F171E47FA}" v="6" dt="2021-06-09T19:37:44.98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5854"/>
    <p:restoredTop sz="94697"/>
  </p:normalViewPr>
  <p:slideViewPr>
    <p:cSldViewPr snapToGrid="0" snapToObjects="1">
      <p:cViewPr varScale="1">
        <p:scale>
          <a:sx n="99" d="100"/>
          <a:sy n="99" d="100"/>
        </p:scale>
        <p:origin x="96" y="3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Volumes\NO%20NAME\Zemfira-2020\12-12-2018-RT-qPCR-FigureS1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Volumes\NO%20NAME\Zemfira-2020\12-12-2018-RT-qPCR-FigureS1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28S'!$D$50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28S'!$K$50:$O$50</c:f>
                <c:numCache>
                  <c:formatCode>General</c:formatCode>
                  <c:ptCount val="5"/>
                  <c:pt idx="0">
                    <c:v>0.13034604496489599</c:v>
                  </c:pt>
                  <c:pt idx="1">
                    <c:v>0.225667044691926</c:v>
                  </c:pt>
                  <c:pt idx="2">
                    <c:v>0.14122397290698599</c:v>
                  </c:pt>
                  <c:pt idx="3">
                    <c:v>0.120650505586054</c:v>
                  </c:pt>
                  <c:pt idx="4">
                    <c:v>8.2200664890960895E-2</c:v>
                  </c:pt>
                </c:numCache>
              </c:numRef>
            </c:plus>
            <c:minus>
              <c:numRef>
                <c:f>'28S'!$K$50:$O$50</c:f>
                <c:numCache>
                  <c:formatCode>General</c:formatCode>
                  <c:ptCount val="5"/>
                  <c:pt idx="0">
                    <c:v>0.13034604496489599</c:v>
                  </c:pt>
                  <c:pt idx="1">
                    <c:v>0.225667044691926</c:v>
                  </c:pt>
                  <c:pt idx="2">
                    <c:v>0.14122397290698599</c:v>
                  </c:pt>
                  <c:pt idx="3">
                    <c:v>0.120650505586054</c:v>
                  </c:pt>
                  <c:pt idx="4">
                    <c:v>8.2200664890960895E-2</c:v>
                  </c:pt>
                </c:numCache>
              </c:numRef>
            </c:minus>
          </c:errBars>
          <c:cat>
            <c:numRef>
              <c:f>'28S'!$E$49:$I$49</c:f>
              <c:numCache>
                <c:formatCode>General</c:formatCode>
                <c:ptCount val="5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8</c:v>
                </c:pt>
              </c:numCache>
            </c:numRef>
          </c:cat>
          <c:val>
            <c:numRef>
              <c:f>'28S'!$E$50:$I$50</c:f>
              <c:numCache>
                <c:formatCode>General</c:formatCode>
                <c:ptCount val="5"/>
                <c:pt idx="0">
                  <c:v>1.0058967326702279</c:v>
                </c:pt>
                <c:pt idx="1">
                  <c:v>0.96315421000764501</c:v>
                </c:pt>
                <c:pt idx="2">
                  <c:v>0.93073684812597202</c:v>
                </c:pt>
                <c:pt idx="3">
                  <c:v>0.75821784238185097</c:v>
                </c:pt>
                <c:pt idx="4">
                  <c:v>0.693380217149812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0DF-CD47-A1FD-0774C068F06F}"/>
            </c:ext>
          </c:extLst>
        </c:ser>
        <c:ser>
          <c:idx val="1"/>
          <c:order val="1"/>
          <c:tx>
            <c:strRef>
              <c:f>'28S'!$D$51</c:f>
              <c:strCache>
                <c:ptCount val="1"/>
                <c:pt idx="0">
                  <c:v>C14DM-</c:v>
                </c:pt>
              </c:strCache>
            </c:strRef>
          </c:tx>
          <c:spPr>
            <a:solidFill>
              <a:schemeClr val="accent2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28S'!$K$51:$O$51</c:f>
                <c:numCache>
                  <c:formatCode>General</c:formatCode>
                  <c:ptCount val="5"/>
                  <c:pt idx="0">
                    <c:v>5.0983092034790199E-2</c:v>
                  </c:pt>
                  <c:pt idx="1">
                    <c:v>3.9309730103631001E-2</c:v>
                  </c:pt>
                  <c:pt idx="2">
                    <c:v>4.3066703270805903E-3</c:v>
                  </c:pt>
                  <c:pt idx="3">
                    <c:v>4.0726558487413203E-2</c:v>
                  </c:pt>
                  <c:pt idx="4">
                    <c:v>2.6234898805118801E-2</c:v>
                  </c:pt>
                </c:numCache>
              </c:numRef>
            </c:plus>
            <c:minus>
              <c:numRef>
                <c:f>'28S'!$K$51:$O$51</c:f>
                <c:numCache>
                  <c:formatCode>General</c:formatCode>
                  <c:ptCount val="5"/>
                  <c:pt idx="0">
                    <c:v>5.0983092034790199E-2</c:v>
                  </c:pt>
                  <c:pt idx="1">
                    <c:v>3.9309730103631001E-2</c:v>
                  </c:pt>
                  <c:pt idx="2">
                    <c:v>4.3066703270805903E-3</c:v>
                  </c:pt>
                  <c:pt idx="3">
                    <c:v>4.0726558487413203E-2</c:v>
                  </c:pt>
                  <c:pt idx="4">
                    <c:v>2.6234898805118801E-2</c:v>
                  </c:pt>
                </c:numCache>
              </c:numRef>
            </c:minus>
          </c:errBars>
          <c:cat>
            <c:numRef>
              <c:f>'28S'!$E$49:$I$49</c:f>
              <c:numCache>
                <c:formatCode>General</c:formatCode>
                <c:ptCount val="5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8</c:v>
                </c:pt>
              </c:numCache>
            </c:numRef>
          </c:cat>
          <c:val>
            <c:numRef>
              <c:f>'28S'!$E$51:$I$51</c:f>
              <c:numCache>
                <c:formatCode>General</c:formatCode>
                <c:ptCount val="5"/>
                <c:pt idx="0">
                  <c:v>1.0008654762351019</c:v>
                </c:pt>
                <c:pt idx="1">
                  <c:v>0.72786517853534805</c:v>
                </c:pt>
                <c:pt idx="2">
                  <c:v>0.711540400513616</c:v>
                </c:pt>
                <c:pt idx="3">
                  <c:v>0.57071818775446803</c:v>
                </c:pt>
                <c:pt idx="4">
                  <c:v>0.527851219929366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0DF-CD47-A1FD-0774C068F06F}"/>
            </c:ext>
          </c:extLst>
        </c:ser>
        <c:ser>
          <c:idx val="2"/>
          <c:order val="2"/>
          <c:tx>
            <c:strRef>
              <c:f>'28S'!$D$52</c:f>
              <c:strCache>
                <c:ptCount val="1"/>
                <c:pt idx="0">
                  <c:v>C14DM-/AB</c:v>
                </c:pt>
              </c:strCache>
            </c:strRef>
          </c:tx>
          <c:spPr>
            <a:solidFill>
              <a:schemeClr val="accent3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28S'!$K$52:$O$52</c:f>
                <c:numCache>
                  <c:formatCode>General</c:formatCode>
                  <c:ptCount val="5"/>
                  <c:pt idx="0">
                    <c:v>3.9542163932844203E-2</c:v>
                  </c:pt>
                  <c:pt idx="1">
                    <c:v>4.75417080571576E-2</c:v>
                  </c:pt>
                  <c:pt idx="2">
                    <c:v>8.5444206056559904E-2</c:v>
                  </c:pt>
                  <c:pt idx="3">
                    <c:v>4.7569348217290003E-2</c:v>
                  </c:pt>
                  <c:pt idx="4">
                    <c:v>3.7337083953729998E-2</c:v>
                  </c:pt>
                </c:numCache>
              </c:numRef>
            </c:plus>
            <c:minus>
              <c:numRef>
                <c:f>'28S'!$K$52:$O$52</c:f>
                <c:numCache>
                  <c:formatCode>General</c:formatCode>
                  <c:ptCount val="5"/>
                  <c:pt idx="0">
                    <c:v>3.9542163932844203E-2</c:v>
                  </c:pt>
                  <c:pt idx="1">
                    <c:v>4.75417080571576E-2</c:v>
                  </c:pt>
                  <c:pt idx="2">
                    <c:v>8.5444206056559904E-2</c:v>
                  </c:pt>
                  <c:pt idx="3">
                    <c:v>4.7569348217290003E-2</c:v>
                  </c:pt>
                  <c:pt idx="4">
                    <c:v>3.7337083953729998E-2</c:v>
                  </c:pt>
                </c:numCache>
              </c:numRef>
            </c:minus>
          </c:errBars>
          <c:cat>
            <c:numRef>
              <c:f>'28S'!$E$49:$I$49</c:f>
              <c:numCache>
                <c:formatCode>General</c:formatCode>
                <c:ptCount val="5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8</c:v>
                </c:pt>
              </c:numCache>
            </c:numRef>
          </c:cat>
          <c:val>
            <c:numRef>
              <c:f>'28S'!$E$52:$I$52</c:f>
              <c:numCache>
                <c:formatCode>General</c:formatCode>
                <c:ptCount val="5"/>
                <c:pt idx="0">
                  <c:v>1.00051377635667</c:v>
                </c:pt>
                <c:pt idx="1">
                  <c:v>1.0243332502281211</c:v>
                </c:pt>
                <c:pt idx="2">
                  <c:v>1.03067012602546</c:v>
                </c:pt>
                <c:pt idx="3">
                  <c:v>0.81604839043758204</c:v>
                </c:pt>
                <c:pt idx="4">
                  <c:v>0.859511608426502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0DF-CD47-A1FD-0774C068F06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029389744"/>
        <c:axId val="-2029401168"/>
      </c:barChart>
      <c:catAx>
        <c:axId val="-2029389744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rgbClr val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029401168"/>
        <c:crosses val="autoZero"/>
        <c:auto val="1"/>
        <c:lblAlgn val="ctr"/>
        <c:lblOffset val="100"/>
        <c:noMultiLvlLbl val="0"/>
      </c:catAx>
      <c:valAx>
        <c:axId val="-2029401168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rgbClr val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02938974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rgbClr val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18S'!$E$50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18S'!$L$50:$P$50</c:f>
                <c:numCache>
                  <c:formatCode>General</c:formatCode>
                  <c:ptCount val="5"/>
                  <c:pt idx="0">
                    <c:v>0.14056554650376599</c:v>
                  </c:pt>
                  <c:pt idx="1">
                    <c:v>0.25009335553443002</c:v>
                  </c:pt>
                  <c:pt idx="2">
                    <c:v>0.15426213029658001</c:v>
                  </c:pt>
                  <c:pt idx="3">
                    <c:v>0.115651638506042</c:v>
                  </c:pt>
                  <c:pt idx="4">
                    <c:v>8.4736365950136006E-2</c:v>
                  </c:pt>
                </c:numCache>
              </c:numRef>
            </c:plus>
            <c:minus>
              <c:numRef>
                <c:f>'18S'!$L$50:$P$50</c:f>
                <c:numCache>
                  <c:formatCode>General</c:formatCode>
                  <c:ptCount val="5"/>
                  <c:pt idx="0">
                    <c:v>0.14056554650376599</c:v>
                  </c:pt>
                  <c:pt idx="1">
                    <c:v>0.25009335553443002</c:v>
                  </c:pt>
                  <c:pt idx="2">
                    <c:v>0.15426213029658001</c:v>
                  </c:pt>
                  <c:pt idx="3">
                    <c:v>0.115651638506042</c:v>
                  </c:pt>
                  <c:pt idx="4">
                    <c:v>8.4736365950136006E-2</c:v>
                  </c:pt>
                </c:numCache>
              </c:numRef>
            </c:minus>
          </c:errBars>
          <c:cat>
            <c:numRef>
              <c:f>'18S'!$F$49:$J$49</c:f>
              <c:numCache>
                <c:formatCode>General</c:formatCode>
                <c:ptCount val="5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8</c:v>
                </c:pt>
              </c:numCache>
            </c:numRef>
          </c:cat>
          <c:val>
            <c:numRef>
              <c:f>'18S'!$F$50:$J$50</c:f>
              <c:numCache>
                <c:formatCode>General</c:formatCode>
                <c:ptCount val="5"/>
                <c:pt idx="0">
                  <c:v>1.0068253185845391</c:v>
                </c:pt>
                <c:pt idx="1">
                  <c:v>1.0474538502858279</c:v>
                </c:pt>
                <c:pt idx="2">
                  <c:v>0.88700165578860402</c:v>
                </c:pt>
                <c:pt idx="3">
                  <c:v>0.75363143965107304</c:v>
                </c:pt>
                <c:pt idx="4">
                  <c:v>0.66926917840058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839-2946-A179-BF07B0EF754F}"/>
            </c:ext>
          </c:extLst>
        </c:ser>
        <c:ser>
          <c:idx val="1"/>
          <c:order val="1"/>
          <c:tx>
            <c:strRef>
              <c:f>'18S'!$E$51</c:f>
              <c:strCache>
                <c:ptCount val="1"/>
                <c:pt idx="0">
                  <c:v>C14-DM-</c:v>
                </c:pt>
              </c:strCache>
            </c:strRef>
          </c:tx>
          <c:spPr>
            <a:solidFill>
              <a:schemeClr val="accent2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18S'!$L$51:$P$51</c:f>
                <c:numCache>
                  <c:formatCode>General</c:formatCode>
                  <c:ptCount val="5"/>
                  <c:pt idx="0">
                    <c:v>3.1315923966250499E-2</c:v>
                  </c:pt>
                  <c:pt idx="1">
                    <c:v>1.7414747918177501E-2</c:v>
                  </c:pt>
                  <c:pt idx="2">
                    <c:v>1.9505021451649798E-2</c:v>
                  </c:pt>
                  <c:pt idx="3">
                    <c:v>4.3931623222642699E-2</c:v>
                  </c:pt>
                  <c:pt idx="4">
                    <c:v>2.0572258873833099E-2</c:v>
                  </c:pt>
                </c:numCache>
              </c:numRef>
            </c:plus>
            <c:minus>
              <c:numRef>
                <c:f>'18S'!$L$51:$P$51</c:f>
                <c:numCache>
                  <c:formatCode>General</c:formatCode>
                  <c:ptCount val="5"/>
                  <c:pt idx="0">
                    <c:v>3.1315923966250499E-2</c:v>
                  </c:pt>
                  <c:pt idx="1">
                    <c:v>1.7414747918177501E-2</c:v>
                  </c:pt>
                  <c:pt idx="2">
                    <c:v>1.9505021451649798E-2</c:v>
                  </c:pt>
                  <c:pt idx="3">
                    <c:v>4.3931623222642699E-2</c:v>
                  </c:pt>
                  <c:pt idx="4">
                    <c:v>2.0572258873833099E-2</c:v>
                  </c:pt>
                </c:numCache>
              </c:numRef>
            </c:minus>
          </c:errBars>
          <c:cat>
            <c:numRef>
              <c:f>'18S'!$F$49:$J$49</c:f>
              <c:numCache>
                <c:formatCode>General</c:formatCode>
                <c:ptCount val="5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8</c:v>
                </c:pt>
              </c:numCache>
            </c:numRef>
          </c:cat>
          <c:val>
            <c:numRef>
              <c:f>'18S'!$F$51:$J$51</c:f>
              <c:numCache>
                <c:formatCode>General</c:formatCode>
                <c:ptCount val="5"/>
                <c:pt idx="0">
                  <c:v>1.000326041056651</c:v>
                </c:pt>
                <c:pt idx="1">
                  <c:v>0.73863518163807096</c:v>
                </c:pt>
                <c:pt idx="2">
                  <c:v>0.72900914734045197</c:v>
                </c:pt>
                <c:pt idx="3">
                  <c:v>0.56825021158150202</c:v>
                </c:pt>
                <c:pt idx="4">
                  <c:v>0.553760254283141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839-2946-A179-BF07B0EF754F}"/>
            </c:ext>
          </c:extLst>
        </c:ser>
        <c:ser>
          <c:idx val="2"/>
          <c:order val="2"/>
          <c:tx>
            <c:strRef>
              <c:f>'18S'!$E$52</c:f>
              <c:strCache>
                <c:ptCount val="1"/>
                <c:pt idx="0">
                  <c:v>C14DM-/AB</c:v>
                </c:pt>
              </c:strCache>
            </c:strRef>
          </c:tx>
          <c:spPr>
            <a:solidFill>
              <a:schemeClr val="accent3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18S'!$L$52:$P$52</c:f>
                <c:numCache>
                  <c:formatCode>General</c:formatCode>
                  <c:ptCount val="5"/>
                  <c:pt idx="0">
                    <c:v>5.7506037462562602E-2</c:v>
                  </c:pt>
                  <c:pt idx="1">
                    <c:v>5.5898293762317801E-2</c:v>
                  </c:pt>
                  <c:pt idx="2">
                    <c:v>5.4681980811432301E-2</c:v>
                  </c:pt>
                  <c:pt idx="3">
                    <c:v>6.2748088358388798E-2</c:v>
                  </c:pt>
                  <c:pt idx="4">
                    <c:v>2.0377335852109799E-2</c:v>
                  </c:pt>
                </c:numCache>
              </c:numRef>
            </c:plus>
            <c:minus>
              <c:numRef>
                <c:f>'18S'!$L$52:$P$52</c:f>
                <c:numCache>
                  <c:formatCode>General</c:formatCode>
                  <c:ptCount val="5"/>
                  <c:pt idx="0">
                    <c:v>5.7506037462562602E-2</c:v>
                  </c:pt>
                  <c:pt idx="1">
                    <c:v>5.5898293762317801E-2</c:v>
                  </c:pt>
                  <c:pt idx="2">
                    <c:v>5.4681980811432301E-2</c:v>
                  </c:pt>
                  <c:pt idx="3">
                    <c:v>6.2748088358388798E-2</c:v>
                  </c:pt>
                  <c:pt idx="4">
                    <c:v>2.0377335852109799E-2</c:v>
                  </c:pt>
                </c:numCache>
              </c:numRef>
            </c:minus>
          </c:errBars>
          <c:cat>
            <c:numRef>
              <c:f>'18S'!$F$49:$J$49</c:f>
              <c:numCache>
                <c:formatCode>General</c:formatCode>
                <c:ptCount val="5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8</c:v>
                </c:pt>
              </c:numCache>
            </c:numRef>
          </c:cat>
          <c:val>
            <c:numRef>
              <c:f>'18S'!$F$52:$J$52</c:f>
              <c:numCache>
                <c:formatCode>General</c:formatCode>
                <c:ptCount val="5"/>
                <c:pt idx="0">
                  <c:v>1.001103645542651</c:v>
                </c:pt>
                <c:pt idx="1">
                  <c:v>0.99000262806889106</c:v>
                </c:pt>
                <c:pt idx="2">
                  <c:v>0.93172557659466704</c:v>
                </c:pt>
                <c:pt idx="3">
                  <c:v>0.81635188996932395</c:v>
                </c:pt>
                <c:pt idx="4">
                  <c:v>0.780604401716433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839-2946-A179-BF07B0EF754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029672784"/>
        <c:axId val="-2086829936"/>
      </c:barChart>
      <c:catAx>
        <c:axId val="-2029672784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086829936"/>
        <c:crosses val="autoZero"/>
        <c:auto val="1"/>
        <c:lblAlgn val="ctr"/>
        <c:lblOffset val="100"/>
        <c:noMultiLvlLbl val="0"/>
      </c:catAx>
      <c:valAx>
        <c:axId val="-2086829936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rgbClr val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02967278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rgbClr val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D19CD2-5E26-AD4C-9B40-E9283BFC773C}" type="datetimeFigureOut">
              <a:rPr lang="en-US" smtClean="0"/>
              <a:t>6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0A9EC-73A3-A94F-9C49-210A3C86C4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57644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D19CD2-5E26-AD4C-9B40-E9283BFC773C}" type="datetimeFigureOut">
              <a:rPr lang="en-US" smtClean="0"/>
              <a:t>6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0A9EC-73A3-A94F-9C49-210A3C86C4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01377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D19CD2-5E26-AD4C-9B40-E9283BFC773C}" type="datetimeFigureOut">
              <a:rPr lang="en-US" smtClean="0"/>
              <a:t>6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0A9EC-73A3-A94F-9C49-210A3C86C4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17756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D19CD2-5E26-AD4C-9B40-E9283BFC773C}" type="datetimeFigureOut">
              <a:rPr lang="en-US" smtClean="0"/>
              <a:t>6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0A9EC-73A3-A94F-9C49-210A3C86C4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8266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D19CD2-5E26-AD4C-9B40-E9283BFC773C}" type="datetimeFigureOut">
              <a:rPr lang="en-US" smtClean="0"/>
              <a:t>6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0A9EC-73A3-A94F-9C49-210A3C86C4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17183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D19CD2-5E26-AD4C-9B40-E9283BFC773C}" type="datetimeFigureOut">
              <a:rPr lang="en-US" smtClean="0"/>
              <a:t>6/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0A9EC-73A3-A94F-9C49-210A3C86C4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83711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D19CD2-5E26-AD4C-9B40-E9283BFC773C}" type="datetimeFigureOut">
              <a:rPr lang="en-US" smtClean="0"/>
              <a:t>6/9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0A9EC-73A3-A94F-9C49-210A3C86C4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6703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D19CD2-5E26-AD4C-9B40-E9283BFC773C}" type="datetimeFigureOut">
              <a:rPr lang="en-US" smtClean="0"/>
              <a:t>6/9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0A9EC-73A3-A94F-9C49-210A3C86C4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58934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D19CD2-5E26-AD4C-9B40-E9283BFC773C}" type="datetimeFigureOut">
              <a:rPr lang="en-US" smtClean="0"/>
              <a:t>6/9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0A9EC-73A3-A94F-9C49-210A3C86C4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24259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D19CD2-5E26-AD4C-9B40-E9283BFC773C}" type="datetimeFigureOut">
              <a:rPr lang="en-US" smtClean="0"/>
              <a:t>6/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0A9EC-73A3-A94F-9C49-210A3C86C4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93242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D19CD2-5E26-AD4C-9B40-E9283BFC773C}" type="datetimeFigureOut">
              <a:rPr lang="en-US" smtClean="0"/>
              <a:t>6/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0A9EC-73A3-A94F-9C49-210A3C86C4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77086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D19CD2-5E26-AD4C-9B40-E9283BFC773C}" type="datetimeFigureOut">
              <a:rPr lang="en-US" smtClean="0"/>
              <a:t>6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60A9EC-73A3-A94F-9C49-210A3C86C4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54604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237904" y="5231004"/>
            <a:ext cx="8423692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900" b="1" dirty="0">
                <a:latin typeface="Palatino Linotype" panose="02040502050505030304" pitchFamily="18" charset="0"/>
                <a:ea typeface="Arial" charset="0"/>
                <a:cs typeface="Arial" charset="0"/>
              </a:rPr>
              <a:t>Figure S1. Ribosomal RNA in </a:t>
            </a:r>
            <a:r>
              <a:rPr lang="en-US" sz="900" b="1" i="1" dirty="0">
                <a:cs typeface="Arial" panose="020B0604020202020204" pitchFamily="34" charset="0"/>
              </a:rPr>
              <a:t>c14dm  ̅ </a:t>
            </a:r>
            <a:r>
              <a:rPr lang="en-US" sz="900" b="1" i="1" baseline="30000" dirty="0">
                <a:latin typeface="Palatino Linotype" panose="02040502050505030304" pitchFamily="18" charset="0"/>
                <a:ea typeface="Arial" charset="0"/>
                <a:cs typeface="Arial" charset="0"/>
              </a:rPr>
              <a:t> </a:t>
            </a:r>
            <a:r>
              <a:rPr lang="en-US" sz="900" b="1" dirty="0">
                <a:latin typeface="Palatino Linotype" panose="02040502050505030304" pitchFamily="18" charset="0"/>
                <a:ea typeface="Arial" charset="0"/>
                <a:cs typeface="Arial" charset="0"/>
              </a:rPr>
              <a:t>mutant degrades faster than those in WT and add-back parasites. </a:t>
            </a:r>
            <a:r>
              <a:rPr lang="en-US" sz="900" dirty="0">
                <a:latin typeface="Palatino Linotype" panose="02040502050505030304" pitchFamily="18" charset="0"/>
                <a:ea typeface="Arial" charset="0"/>
                <a:cs typeface="Arial" charset="0"/>
              </a:rPr>
              <a:t>To block transcription and monitor RNA degradation, actinomycin D was added to mid-log cells and equal aliquots of cultures were taken at the indicated times. RT-qPCR reactions to measure the decay of 18S (</a:t>
            </a:r>
            <a:r>
              <a:rPr lang="en-US" sz="900" b="1" dirty="0">
                <a:latin typeface="Palatino Linotype" panose="02040502050505030304" pitchFamily="18" charset="0"/>
                <a:ea typeface="Arial" charset="0"/>
                <a:cs typeface="Arial" charset="0"/>
              </a:rPr>
              <a:t>A</a:t>
            </a:r>
            <a:r>
              <a:rPr lang="en-US" sz="900" dirty="0">
                <a:latin typeface="Palatino Linotype" panose="02040502050505030304" pitchFamily="18" charset="0"/>
                <a:ea typeface="Arial" charset="0"/>
                <a:cs typeface="Arial" charset="0"/>
              </a:rPr>
              <a:t>) and 28S (</a:t>
            </a:r>
            <a:r>
              <a:rPr lang="en-US" sz="900" b="1" dirty="0">
                <a:latin typeface="Palatino Linotype" panose="02040502050505030304" pitchFamily="18" charset="0"/>
                <a:ea typeface="Arial" charset="0"/>
                <a:cs typeface="Arial" charset="0"/>
              </a:rPr>
              <a:t>B</a:t>
            </a:r>
            <a:r>
              <a:rPr lang="en-US" sz="900" dirty="0">
                <a:latin typeface="Palatino Linotype" panose="02040502050505030304" pitchFamily="18" charset="0"/>
                <a:ea typeface="Arial" charset="0"/>
                <a:cs typeface="Arial" charset="0"/>
              </a:rPr>
              <a:t>) rRNAs were performed as described in </a:t>
            </a:r>
            <a:r>
              <a:rPr lang="en-US" sz="900" i="1" dirty="0">
                <a:latin typeface="Palatino Linotype" panose="02040502050505030304" pitchFamily="18" charset="0"/>
                <a:ea typeface="Arial" charset="0"/>
                <a:cs typeface="Arial" charset="0"/>
              </a:rPr>
              <a:t>Materials and Methods</a:t>
            </a:r>
            <a:r>
              <a:rPr lang="en-US" sz="900" dirty="0">
                <a:latin typeface="Palatino Linotype" panose="02040502050505030304" pitchFamily="18" charset="0"/>
                <a:ea typeface="Arial" charset="0"/>
                <a:cs typeface="Arial" charset="0"/>
              </a:rPr>
              <a:t>. Cells not treated with actinomycin D were used as controls. </a:t>
            </a:r>
          </a:p>
        </p:txBody>
      </p:sp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FE9DC8B8-7E72-DB45-88EF-E4CCE6508F4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69666580"/>
              </p:ext>
            </p:extLst>
          </p:nvPr>
        </p:nvGraphicFramePr>
        <p:xfrm>
          <a:off x="5573103" y="984836"/>
          <a:ext cx="3937635" cy="35941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1088664" y="835896"/>
            <a:ext cx="298480" cy="3174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63" b="1" dirty="0"/>
              <a:t>A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5282639" y="835896"/>
            <a:ext cx="290464" cy="3174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63" b="1" dirty="0"/>
              <a:t>B</a:t>
            </a:r>
          </a:p>
        </p:txBody>
      </p:sp>
      <p:sp>
        <p:nvSpPr>
          <p:cNvPr id="11" name="Rectangle 10"/>
          <p:cNvSpPr/>
          <p:nvPr/>
        </p:nvSpPr>
        <p:spPr>
          <a:xfrm>
            <a:off x="7068536" y="1136233"/>
            <a:ext cx="78418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/>
              <a:t>28S </a:t>
            </a:r>
            <a:r>
              <a:rPr lang="en-US" sz="1200" b="1" dirty="0" err="1"/>
              <a:t>rRNA</a:t>
            </a:r>
            <a:endParaRPr lang="en-US" sz="1200" b="1" dirty="0"/>
          </a:p>
        </p:txBody>
      </p:sp>
      <p:sp>
        <p:nvSpPr>
          <p:cNvPr id="14" name="TextBox 13"/>
          <p:cNvSpPr txBox="1"/>
          <p:nvPr/>
        </p:nvSpPr>
        <p:spPr>
          <a:xfrm rot="16200000">
            <a:off x="593758" y="2325269"/>
            <a:ext cx="15456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Relative RNA level</a:t>
            </a:r>
          </a:p>
        </p:txBody>
      </p:sp>
      <p:sp>
        <p:nvSpPr>
          <p:cNvPr id="15" name="TextBox 14"/>
          <p:cNvSpPr txBox="1"/>
          <p:nvPr/>
        </p:nvSpPr>
        <p:spPr>
          <a:xfrm rot="16200000">
            <a:off x="4671223" y="2325269"/>
            <a:ext cx="15456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Relative RNA level</a:t>
            </a:r>
          </a:p>
        </p:txBody>
      </p:sp>
      <p:graphicFrame>
        <p:nvGraphicFramePr>
          <p:cNvPr id="17" name="Chart 1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39360391"/>
              </p:ext>
            </p:extLst>
          </p:nvPr>
        </p:nvGraphicFramePr>
        <p:xfrm>
          <a:off x="1422723" y="994625"/>
          <a:ext cx="3867419" cy="35941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8" name="Rectangle 17"/>
          <p:cNvSpPr/>
          <p:nvPr/>
        </p:nvSpPr>
        <p:spPr>
          <a:xfrm>
            <a:off x="2970223" y="1136232"/>
            <a:ext cx="78418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/>
              <a:t>18S </a:t>
            </a:r>
            <a:r>
              <a:rPr lang="en-US" sz="1200" b="1" dirty="0" err="1"/>
              <a:t>rRNA</a:t>
            </a:r>
            <a:endParaRPr lang="en-US" sz="12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2836738" y="4230318"/>
            <a:ext cx="646331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b="1" i="1" dirty="0">
                <a:cs typeface="Arial" panose="020B0604020202020204" pitchFamily="34" charset="0"/>
              </a:rPr>
              <a:t>c14dm ̅</a:t>
            </a:r>
            <a:endParaRPr lang="en-US" sz="12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3667409" y="4230318"/>
            <a:ext cx="149683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b="1" i="1" dirty="0"/>
              <a:t>c14dm   ̅/</a:t>
            </a:r>
            <a:r>
              <a:rPr lang="en-US" sz="1200" b="1" dirty="0"/>
              <a:t>+C14DM 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7058240" y="4221284"/>
            <a:ext cx="646331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b="1" i="1" dirty="0">
                <a:cs typeface="Arial" panose="020B0604020202020204" pitchFamily="34" charset="0"/>
              </a:rPr>
              <a:t>c14dm ̅</a:t>
            </a:r>
            <a:endParaRPr lang="en-US" sz="12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7850611" y="4221284"/>
            <a:ext cx="145531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b="1" i="1" dirty="0"/>
              <a:t>c14dm   ̅/</a:t>
            </a:r>
            <a:r>
              <a:rPr lang="en-US" sz="1200" b="1" dirty="0"/>
              <a:t>+C14DM 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D3A050F-3AE4-4E40-AE08-87390E4C7EC1}"/>
              </a:ext>
            </a:extLst>
          </p:cNvPr>
          <p:cNvSpPr txBox="1"/>
          <p:nvPr/>
        </p:nvSpPr>
        <p:spPr>
          <a:xfrm>
            <a:off x="2438758" y="4292560"/>
            <a:ext cx="246690" cy="184666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200" b="1" dirty="0"/>
              <a:t>WT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95BBF5A-6D99-4C75-81B9-CDC0E56FD3AC}"/>
              </a:ext>
            </a:extLst>
          </p:cNvPr>
          <p:cNvSpPr txBox="1"/>
          <p:nvPr/>
        </p:nvSpPr>
        <p:spPr>
          <a:xfrm>
            <a:off x="6651934" y="4276484"/>
            <a:ext cx="246690" cy="184666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200" b="1" dirty="0"/>
              <a:t>WT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CC9F924-5112-41E9-B0A0-4B8F3DF0C6DB}"/>
              </a:ext>
            </a:extLst>
          </p:cNvPr>
          <p:cNvSpPr txBox="1"/>
          <p:nvPr/>
        </p:nvSpPr>
        <p:spPr>
          <a:xfrm>
            <a:off x="3098449" y="4578936"/>
            <a:ext cx="769239" cy="215444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400" b="1" dirty="0"/>
              <a:t>Hours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053F726D-0260-471A-8576-A709F58458AA}"/>
              </a:ext>
            </a:extLst>
          </p:cNvPr>
          <p:cNvSpPr txBox="1"/>
          <p:nvPr/>
        </p:nvSpPr>
        <p:spPr>
          <a:xfrm>
            <a:off x="7381405" y="4578936"/>
            <a:ext cx="769239" cy="215444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400" b="1" dirty="0"/>
              <a:t>Hours</a:t>
            </a:r>
          </a:p>
        </p:txBody>
      </p:sp>
    </p:spTree>
    <p:extLst>
      <p:ext uri="{BB962C8B-B14F-4D97-AF65-F5344CB8AC3E}">
        <p14:creationId xmlns:p14="http://schemas.microsoft.com/office/powerpoint/2010/main" val="5680058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111</Words>
  <Application>Microsoft Office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ramysheva, Zemfira</dc:creator>
  <cp:lastModifiedBy>Kai Zhang</cp:lastModifiedBy>
  <cp:revision>6</cp:revision>
  <dcterms:created xsi:type="dcterms:W3CDTF">2021-04-13T21:45:34Z</dcterms:created>
  <dcterms:modified xsi:type="dcterms:W3CDTF">2021-06-09T19:38:08Z</dcterms:modified>
</cp:coreProperties>
</file>